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5" r:id="rId2"/>
  </p:sldIdLst>
  <p:sldSz cx="9144000" cy="6858000" type="screen4x3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96" autoAdjust="0"/>
    <p:restoredTop sz="88471" autoAdjust="0"/>
  </p:normalViewPr>
  <p:slideViewPr>
    <p:cSldViewPr snapToGrid="0">
      <p:cViewPr varScale="1">
        <p:scale>
          <a:sx n="97" d="100"/>
          <a:sy n="97" d="100"/>
        </p:scale>
        <p:origin x="12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ED73D-736B-43AC-AF16-95F5FE026706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C82BAA-9237-40AB-BD5F-D0DFCE56C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8963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79AF69ED-F154-485A-86A5-50488DFE62B7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50963" y="1162050"/>
            <a:ext cx="417988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C095A2F6-EE68-43C4-8F94-F29FE95816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6233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480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495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740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27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296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605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879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821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698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690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307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8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59101" y="966348"/>
            <a:ext cx="742191" cy="3077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2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930398" y="1735085"/>
            <a:ext cx="960061" cy="975893"/>
            <a:chOff x="1736869" y="1283235"/>
            <a:chExt cx="960061" cy="975893"/>
          </a:xfrm>
        </p:grpSpPr>
        <p:sp>
          <p:nvSpPr>
            <p:cNvPr id="5" name="Rounded Rectangle 12"/>
            <p:cNvSpPr/>
            <p:nvPr/>
          </p:nvSpPr>
          <p:spPr bwMode="auto">
            <a:xfrm>
              <a:off x="1736869" y="1769251"/>
              <a:ext cx="960061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753404" y="1418203"/>
              <a:ext cx="530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G</a:t>
              </a:r>
            </a:p>
          </p:txBody>
        </p:sp>
        <p:sp>
          <p:nvSpPr>
            <p:cNvPr id="7" name="Rounded Rectangle 16"/>
            <p:cNvSpPr/>
            <p:nvPr/>
          </p:nvSpPr>
          <p:spPr>
            <a:xfrm>
              <a:off x="1858507" y="1708382"/>
              <a:ext cx="764576" cy="128311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66341" y="1655807"/>
              <a:ext cx="8098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-NLS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18770" y="1283235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3</a:t>
              </a: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1802909" y="2012907"/>
              <a:ext cx="510076" cy="246221"/>
              <a:chOff x="1802909" y="2012907"/>
              <a:chExt cx="510076" cy="246221"/>
            </a:xfrm>
          </p:grpSpPr>
          <p:sp>
            <p:nvSpPr>
              <p:cNvPr id="14" name="Rounded Rectangle 16"/>
              <p:cNvSpPr/>
              <p:nvPr/>
            </p:nvSpPr>
            <p:spPr>
              <a:xfrm>
                <a:off x="1846483" y="2073553"/>
                <a:ext cx="393964" cy="150307"/>
              </a:xfrm>
              <a:prstGeom prst="round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802909" y="201290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r>
                  <a:rPr lang="en-US" sz="1000" baseline="30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846483" y="1649137"/>
              <a:ext cx="185920" cy="114770"/>
              <a:chOff x="2376911" y="5029200"/>
              <a:chExt cx="185920" cy="114770"/>
            </a:xfrm>
          </p:grpSpPr>
          <p:cxnSp>
            <p:nvCxnSpPr>
              <p:cNvPr id="12" name="Straight Connector 11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6" name="Group 15"/>
          <p:cNvGrpSpPr/>
          <p:nvPr/>
        </p:nvGrpSpPr>
        <p:grpSpPr>
          <a:xfrm>
            <a:off x="1446291" y="2759776"/>
            <a:ext cx="2101588" cy="926250"/>
            <a:chOff x="1042853" y="2887291"/>
            <a:chExt cx="2101588" cy="926250"/>
          </a:xfrm>
        </p:grpSpPr>
        <p:sp>
          <p:nvSpPr>
            <p:cNvPr id="17" name="Rounded Rectangle 12"/>
            <p:cNvSpPr/>
            <p:nvPr/>
          </p:nvSpPr>
          <p:spPr bwMode="auto">
            <a:xfrm>
              <a:off x="1042853" y="3302411"/>
              <a:ext cx="2101588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ounded Rectangle 16"/>
            <p:cNvSpPr/>
            <p:nvPr/>
          </p:nvSpPr>
          <p:spPr>
            <a:xfrm>
              <a:off x="2190492" y="3212528"/>
              <a:ext cx="914143" cy="192802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219232" y="3193206"/>
              <a:ext cx="8659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xFLAG-CAS9</a:t>
              </a:r>
            </a:p>
          </p:txBody>
        </p:sp>
        <p:sp>
          <p:nvSpPr>
            <p:cNvPr id="20" name="Rounded Rectangle 16"/>
            <p:cNvSpPr/>
            <p:nvPr/>
          </p:nvSpPr>
          <p:spPr>
            <a:xfrm>
              <a:off x="1152467" y="3606713"/>
              <a:ext cx="393964" cy="150307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080318" y="3536542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r>
                <a:rPr lang="en-US" sz="12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1278159" y="3170223"/>
              <a:ext cx="185920" cy="114770"/>
              <a:chOff x="2376911" y="5029200"/>
              <a:chExt cx="185920" cy="114770"/>
            </a:xfrm>
          </p:grpSpPr>
          <p:cxnSp>
            <p:nvCxnSpPr>
              <p:cNvPr id="29" name="Straight Connector 28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TextBox 22"/>
            <p:cNvSpPr txBox="1"/>
            <p:nvPr/>
          </p:nvSpPr>
          <p:spPr>
            <a:xfrm>
              <a:off x="1261964" y="2967824"/>
              <a:ext cx="2853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  <p:sp>
          <p:nvSpPr>
            <p:cNvPr id="24" name="Rounded Rectangle 16"/>
            <p:cNvSpPr/>
            <p:nvPr/>
          </p:nvSpPr>
          <p:spPr>
            <a:xfrm>
              <a:off x="1850874" y="3208714"/>
              <a:ext cx="331667" cy="193314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ounded Rectangle 16"/>
            <p:cNvSpPr/>
            <p:nvPr/>
          </p:nvSpPr>
          <p:spPr>
            <a:xfrm>
              <a:off x="1301838" y="3220128"/>
              <a:ext cx="541085" cy="188914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73510" y="3188632"/>
              <a:ext cx="700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ate2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18894" y="3171175"/>
              <a:ext cx="450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A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875741" y="2887291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8</a:t>
              </a: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6092041" y="2757495"/>
            <a:ext cx="2101588" cy="933610"/>
            <a:chOff x="5688603" y="2885010"/>
            <a:chExt cx="2101588" cy="933610"/>
          </a:xfrm>
        </p:grpSpPr>
        <p:sp>
          <p:nvSpPr>
            <p:cNvPr id="32" name="Rounded Rectangle 12"/>
            <p:cNvSpPr/>
            <p:nvPr/>
          </p:nvSpPr>
          <p:spPr bwMode="auto">
            <a:xfrm>
              <a:off x="5688603" y="3307490"/>
              <a:ext cx="2101588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ounded Rectangle 16"/>
            <p:cNvSpPr/>
            <p:nvPr/>
          </p:nvSpPr>
          <p:spPr>
            <a:xfrm>
              <a:off x="6836242" y="3217607"/>
              <a:ext cx="914143" cy="192802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855651" y="3199587"/>
              <a:ext cx="8659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-3xFLAG</a:t>
              </a:r>
            </a:p>
          </p:txBody>
        </p:sp>
        <p:sp>
          <p:nvSpPr>
            <p:cNvPr id="35" name="Rounded Rectangle 16"/>
            <p:cNvSpPr/>
            <p:nvPr/>
          </p:nvSpPr>
          <p:spPr>
            <a:xfrm>
              <a:off x="5798217" y="3611792"/>
              <a:ext cx="393964" cy="150307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726068" y="3541621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r>
                <a:rPr lang="en-US" sz="12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5932618" y="3175302"/>
              <a:ext cx="185920" cy="114770"/>
              <a:chOff x="2376911" y="5029200"/>
              <a:chExt cx="185920" cy="114770"/>
            </a:xfrm>
          </p:grpSpPr>
          <p:cxnSp>
            <p:nvCxnSpPr>
              <p:cNvPr id="44" name="Straight Connector 43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/>
            <p:cNvSpPr txBox="1"/>
            <p:nvPr/>
          </p:nvSpPr>
          <p:spPr>
            <a:xfrm>
              <a:off x="5907714" y="2972903"/>
              <a:ext cx="2853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  <p:sp>
          <p:nvSpPr>
            <p:cNvPr id="39" name="Rounded Rectangle 16"/>
            <p:cNvSpPr/>
            <p:nvPr/>
          </p:nvSpPr>
          <p:spPr>
            <a:xfrm>
              <a:off x="6496624" y="3213793"/>
              <a:ext cx="331667" cy="193314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ounded Rectangle 16"/>
            <p:cNvSpPr/>
            <p:nvPr/>
          </p:nvSpPr>
          <p:spPr>
            <a:xfrm>
              <a:off x="5947588" y="3225207"/>
              <a:ext cx="541085" cy="188914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920109" y="3188822"/>
              <a:ext cx="700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ate2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445982" y="3185585"/>
              <a:ext cx="450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A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496624" y="2885010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10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3788589" y="2756182"/>
            <a:ext cx="2182798" cy="922856"/>
            <a:chOff x="3385151" y="2883697"/>
            <a:chExt cx="2182798" cy="922856"/>
          </a:xfrm>
        </p:grpSpPr>
        <p:sp>
          <p:nvSpPr>
            <p:cNvPr id="47" name="Rounded Rectangle 12"/>
            <p:cNvSpPr/>
            <p:nvPr/>
          </p:nvSpPr>
          <p:spPr bwMode="auto">
            <a:xfrm>
              <a:off x="3385151" y="3295423"/>
              <a:ext cx="2101588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ounded Rectangle 16"/>
            <p:cNvSpPr/>
            <p:nvPr/>
          </p:nvSpPr>
          <p:spPr>
            <a:xfrm>
              <a:off x="4532790" y="3205540"/>
              <a:ext cx="914143" cy="192802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423084" y="3188822"/>
              <a:ext cx="11448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xFLAG-linker-CAS9</a:t>
              </a:r>
            </a:p>
          </p:txBody>
        </p:sp>
        <p:sp>
          <p:nvSpPr>
            <p:cNvPr id="50" name="Rounded Rectangle 16"/>
            <p:cNvSpPr/>
            <p:nvPr/>
          </p:nvSpPr>
          <p:spPr>
            <a:xfrm>
              <a:off x="3494765" y="3599725"/>
              <a:ext cx="393964" cy="150307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422616" y="3529554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r>
                <a:rPr lang="en-US" sz="12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3620457" y="3163235"/>
              <a:ext cx="185920" cy="114770"/>
              <a:chOff x="2376911" y="5029200"/>
              <a:chExt cx="185920" cy="114770"/>
            </a:xfrm>
          </p:grpSpPr>
          <p:cxnSp>
            <p:nvCxnSpPr>
              <p:cNvPr id="59" name="Straight Connector 58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Arrow Connector 59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TextBox 52"/>
            <p:cNvSpPr txBox="1"/>
            <p:nvPr/>
          </p:nvSpPr>
          <p:spPr>
            <a:xfrm>
              <a:off x="3604262" y="2960836"/>
              <a:ext cx="2853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  <p:sp>
          <p:nvSpPr>
            <p:cNvPr id="54" name="Rounded Rectangle 16"/>
            <p:cNvSpPr/>
            <p:nvPr/>
          </p:nvSpPr>
          <p:spPr>
            <a:xfrm>
              <a:off x="4193172" y="3201726"/>
              <a:ext cx="331667" cy="193314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ounded Rectangle 16"/>
            <p:cNvSpPr/>
            <p:nvPr/>
          </p:nvSpPr>
          <p:spPr>
            <a:xfrm>
              <a:off x="3644136" y="3213140"/>
              <a:ext cx="541085" cy="188914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611677" y="3183875"/>
              <a:ext cx="700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ate2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161192" y="3173518"/>
              <a:ext cx="450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A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176442" y="2883697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9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3092748" y="1736690"/>
            <a:ext cx="984775" cy="993163"/>
            <a:chOff x="2899219" y="1284840"/>
            <a:chExt cx="984775" cy="993163"/>
          </a:xfrm>
        </p:grpSpPr>
        <p:sp>
          <p:nvSpPr>
            <p:cNvPr id="62" name="Rounded Rectangle 12"/>
            <p:cNvSpPr/>
            <p:nvPr/>
          </p:nvSpPr>
          <p:spPr bwMode="auto">
            <a:xfrm>
              <a:off x="2899219" y="1770856"/>
              <a:ext cx="960061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982111" y="1431014"/>
              <a:ext cx="530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  <p:sp>
          <p:nvSpPr>
            <p:cNvPr id="64" name="Rounded Rectangle 16"/>
            <p:cNvSpPr/>
            <p:nvPr/>
          </p:nvSpPr>
          <p:spPr>
            <a:xfrm>
              <a:off x="3094704" y="1709987"/>
              <a:ext cx="764576" cy="128311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074157" y="1657412"/>
              <a:ext cx="8098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-NLS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254967" y="1284840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4</a:t>
              </a:r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3079471" y="1663069"/>
              <a:ext cx="185920" cy="114770"/>
              <a:chOff x="2376911" y="5029200"/>
              <a:chExt cx="185920" cy="114770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oup 67"/>
            <p:cNvGrpSpPr/>
            <p:nvPr/>
          </p:nvGrpSpPr>
          <p:grpSpPr>
            <a:xfrm>
              <a:off x="2974993" y="2031782"/>
              <a:ext cx="510076" cy="246221"/>
              <a:chOff x="1802909" y="2012907"/>
              <a:chExt cx="510076" cy="246221"/>
            </a:xfrm>
          </p:grpSpPr>
          <p:sp>
            <p:nvSpPr>
              <p:cNvPr id="69" name="Rounded Rectangle 16"/>
              <p:cNvSpPr/>
              <p:nvPr/>
            </p:nvSpPr>
            <p:spPr>
              <a:xfrm>
                <a:off x="1846483" y="2073553"/>
                <a:ext cx="393964" cy="150307"/>
              </a:xfrm>
              <a:prstGeom prst="round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1802909" y="201290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r>
                  <a:rPr lang="en-US" sz="1000" baseline="30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</p:grpSp>
      </p:grpSp>
      <p:grpSp>
        <p:nvGrpSpPr>
          <p:cNvPr id="73" name="Group 72"/>
          <p:cNvGrpSpPr/>
          <p:nvPr/>
        </p:nvGrpSpPr>
        <p:grpSpPr>
          <a:xfrm>
            <a:off x="4250329" y="1734148"/>
            <a:ext cx="984581" cy="1006119"/>
            <a:chOff x="4056800" y="1282298"/>
            <a:chExt cx="984581" cy="1006119"/>
          </a:xfrm>
        </p:grpSpPr>
        <p:sp>
          <p:nvSpPr>
            <p:cNvPr id="74" name="Rounded Rectangle 12"/>
            <p:cNvSpPr/>
            <p:nvPr/>
          </p:nvSpPr>
          <p:spPr bwMode="auto">
            <a:xfrm>
              <a:off x="4056800" y="1777839"/>
              <a:ext cx="960061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137715" y="1437793"/>
              <a:ext cx="530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G</a:t>
              </a:r>
            </a:p>
          </p:txBody>
        </p:sp>
        <p:sp>
          <p:nvSpPr>
            <p:cNvPr id="76" name="Rounded Rectangle 16"/>
            <p:cNvSpPr/>
            <p:nvPr/>
          </p:nvSpPr>
          <p:spPr>
            <a:xfrm>
              <a:off x="4252285" y="1716970"/>
              <a:ext cx="764576" cy="128311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231544" y="1664395"/>
              <a:ext cx="8098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S-CAS9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412548" y="1282298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5</a:t>
              </a:r>
            </a:p>
          </p:txBody>
        </p:sp>
        <p:grpSp>
          <p:nvGrpSpPr>
            <p:cNvPr id="79" name="Group 78"/>
            <p:cNvGrpSpPr/>
            <p:nvPr/>
          </p:nvGrpSpPr>
          <p:grpSpPr>
            <a:xfrm>
              <a:off x="4242103" y="1667771"/>
              <a:ext cx="185920" cy="114770"/>
              <a:chOff x="2376911" y="5029200"/>
              <a:chExt cx="185920" cy="114770"/>
            </a:xfrm>
          </p:grpSpPr>
          <p:cxnSp>
            <p:nvCxnSpPr>
              <p:cNvPr id="83" name="Straight Connector 82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Arrow Connector 83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 79"/>
            <p:cNvGrpSpPr/>
            <p:nvPr/>
          </p:nvGrpSpPr>
          <p:grpSpPr>
            <a:xfrm>
              <a:off x="4135255" y="2042196"/>
              <a:ext cx="510076" cy="246221"/>
              <a:chOff x="1802909" y="2012907"/>
              <a:chExt cx="510076" cy="246221"/>
            </a:xfrm>
          </p:grpSpPr>
          <p:sp>
            <p:nvSpPr>
              <p:cNvPr id="81" name="Rounded Rectangle 16"/>
              <p:cNvSpPr/>
              <p:nvPr/>
            </p:nvSpPr>
            <p:spPr>
              <a:xfrm>
                <a:off x="1846483" y="2073553"/>
                <a:ext cx="393964" cy="150307"/>
              </a:xfrm>
              <a:prstGeom prst="round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1802909" y="201290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r>
                  <a:rPr lang="en-US" sz="1000" baseline="30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</p:grpSp>
      </p:grpSp>
      <p:grpSp>
        <p:nvGrpSpPr>
          <p:cNvPr id="85" name="Group 84"/>
          <p:cNvGrpSpPr/>
          <p:nvPr/>
        </p:nvGrpSpPr>
        <p:grpSpPr>
          <a:xfrm>
            <a:off x="5445375" y="1734154"/>
            <a:ext cx="960061" cy="995699"/>
            <a:chOff x="5251846" y="1282304"/>
            <a:chExt cx="960061" cy="995699"/>
          </a:xfrm>
        </p:grpSpPr>
        <p:sp>
          <p:nvSpPr>
            <p:cNvPr id="86" name="Rounded Rectangle 12"/>
            <p:cNvSpPr/>
            <p:nvPr/>
          </p:nvSpPr>
          <p:spPr bwMode="auto">
            <a:xfrm>
              <a:off x="5251846" y="1768320"/>
              <a:ext cx="960061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331230" y="1418203"/>
              <a:ext cx="530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G</a:t>
              </a:r>
            </a:p>
          </p:txBody>
        </p:sp>
        <p:sp>
          <p:nvSpPr>
            <p:cNvPr id="88" name="Rounded Rectangle 16"/>
            <p:cNvSpPr/>
            <p:nvPr/>
          </p:nvSpPr>
          <p:spPr>
            <a:xfrm>
              <a:off x="5447331" y="1707451"/>
              <a:ext cx="764576" cy="128311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5571654" y="1654876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5607594" y="1282304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6</a:t>
              </a:r>
            </a:p>
          </p:txBody>
        </p:sp>
        <p:grpSp>
          <p:nvGrpSpPr>
            <p:cNvPr id="91" name="Group 90"/>
            <p:cNvGrpSpPr/>
            <p:nvPr/>
          </p:nvGrpSpPr>
          <p:grpSpPr>
            <a:xfrm>
              <a:off x="5435307" y="1657147"/>
              <a:ext cx="185920" cy="114770"/>
              <a:chOff x="2376911" y="5029200"/>
              <a:chExt cx="185920" cy="114770"/>
            </a:xfrm>
          </p:grpSpPr>
          <p:cxnSp>
            <p:nvCxnSpPr>
              <p:cNvPr id="95" name="Straight Connector 94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Arrow Connector 95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 91"/>
            <p:cNvGrpSpPr/>
            <p:nvPr/>
          </p:nvGrpSpPr>
          <p:grpSpPr>
            <a:xfrm>
              <a:off x="5336308" y="2031782"/>
              <a:ext cx="510076" cy="246221"/>
              <a:chOff x="1802909" y="2012907"/>
              <a:chExt cx="510076" cy="246221"/>
            </a:xfrm>
          </p:grpSpPr>
          <p:sp>
            <p:nvSpPr>
              <p:cNvPr id="93" name="Rounded Rectangle 16"/>
              <p:cNvSpPr/>
              <p:nvPr/>
            </p:nvSpPr>
            <p:spPr>
              <a:xfrm>
                <a:off x="1846483" y="2073553"/>
                <a:ext cx="393964" cy="150307"/>
              </a:xfrm>
              <a:prstGeom prst="round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1802909" y="201290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r>
                  <a:rPr lang="en-US" sz="1000" baseline="30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</p:grpSp>
      </p:grpSp>
      <p:grpSp>
        <p:nvGrpSpPr>
          <p:cNvPr id="97" name="Group 96"/>
          <p:cNvGrpSpPr/>
          <p:nvPr/>
        </p:nvGrpSpPr>
        <p:grpSpPr>
          <a:xfrm>
            <a:off x="6655376" y="1736690"/>
            <a:ext cx="1030626" cy="974288"/>
            <a:chOff x="6461847" y="1284840"/>
            <a:chExt cx="1030626" cy="974288"/>
          </a:xfrm>
        </p:grpSpPr>
        <p:sp>
          <p:nvSpPr>
            <p:cNvPr id="98" name="Rounded Rectangle 12"/>
            <p:cNvSpPr/>
            <p:nvPr/>
          </p:nvSpPr>
          <p:spPr bwMode="auto">
            <a:xfrm>
              <a:off x="6461847" y="1770856"/>
              <a:ext cx="960061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6515419" y="1412311"/>
              <a:ext cx="530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G</a:t>
              </a:r>
            </a:p>
          </p:txBody>
        </p:sp>
        <p:sp>
          <p:nvSpPr>
            <p:cNvPr id="100" name="Rounded Rectangle 16"/>
            <p:cNvSpPr/>
            <p:nvPr/>
          </p:nvSpPr>
          <p:spPr>
            <a:xfrm>
              <a:off x="6657332" y="1709987"/>
              <a:ext cx="764576" cy="128311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6570426" y="1663270"/>
              <a:ext cx="9220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S-CAS9-NLS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6817595" y="1284840"/>
              <a:ext cx="49532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07</a:t>
              </a:r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6637378" y="1648206"/>
              <a:ext cx="185920" cy="114770"/>
              <a:chOff x="2376911" y="5029200"/>
              <a:chExt cx="185920" cy="114770"/>
            </a:xfrm>
          </p:grpSpPr>
          <p:cxnSp>
            <p:nvCxnSpPr>
              <p:cNvPr id="107" name="Straight Connector 106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Arrow Connector 107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Group 103"/>
            <p:cNvGrpSpPr/>
            <p:nvPr/>
          </p:nvGrpSpPr>
          <p:grpSpPr>
            <a:xfrm>
              <a:off x="6537479" y="2012907"/>
              <a:ext cx="510076" cy="246221"/>
              <a:chOff x="1802909" y="2012907"/>
              <a:chExt cx="510076" cy="246221"/>
            </a:xfrm>
          </p:grpSpPr>
          <p:sp>
            <p:nvSpPr>
              <p:cNvPr id="105" name="Rounded Rectangle 16"/>
              <p:cNvSpPr/>
              <p:nvPr/>
            </p:nvSpPr>
            <p:spPr>
              <a:xfrm>
                <a:off x="1846483" y="2073553"/>
                <a:ext cx="393964" cy="150307"/>
              </a:xfrm>
              <a:prstGeom prst="round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802909" y="201290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r>
                  <a:rPr lang="en-US" sz="1000" baseline="30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</p:grpSp>
      </p:grpSp>
      <p:grpSp>
        <p:nvGrpSpPr>
          <p:cNvPr id="109" name="Group 108"/>
          <p:cNvGrpSpPr/>
          <p:nvPr/>
        </p:nvGrpSpPr>
        <p:grpSpPr>
          <a:xfrm>
            <a:off x="2622556" y="3762147"/>
            <a:ext cx="2101588" cy="858216"/>
            <a:chOff x="1042853" y="2955325"/>
            <a:chExt cx="2101588" cy="858216"/>
          </a:xfrm>
        </p:grpSpPr>
        <p:sp>
          <p:nvSpPr>
            <p:cNvPr id="110" name="Rounded Rectangle 12"/>
            <p:cNvSpPr/>
            <p:nvPr/>
          </p:nvSpPr>
          <p:spPr bwMode="auto">
            <a:xfrm>
              <a:off x="1042853" y="3302411"/>
              <a:ext cx="2101588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ounded Rectangle 16"/>
            <p:cNvSpPr/>
            <p:nvPr/>
          </p:nvSpPr>
          <p:spPr>
            <a:xfrm>
              <a:off x="2190492" y="3212528"/>
              <a:ext cx="914143" cy="192802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209901" y="3193206"/>
              <a:ext cx="8659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xFLAG-CAS9</a:t>
              </a:r>
            </a:p>
          </p:txBody>
        </p:sp>
        <p:sp>
          <p:nvSpPr>
            <p:cNvPr id="113" name="Rounded Rectangle 16"/>
            <p:cNvSpPr/>
            <p:nvPr/>
          </p:nvSpPr>
          <p:spPr>
            <a:xfrm>
              <a:off x="1152467" y="3606713"/>
              <a:ext cx="393964" cy="150307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1080318" y="3536542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r>
                <a:rPr lang="en-US" sz="12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15" name="Group 114"/>
            <p:cNvGrpSpPr/>
            <p:nvPr/>
          </p:nvGrpSpPr>
          <p:grpSpPr>
            <a:xfrm>
              <a:off x="1278159" y="3170223"/>
              <a:ext cx="185920" cy="114770"/>
              <a:chOff x="2376911" y="5029200"/>
              <a:chExt cx="185920" cy="114770"/>
            </a:xfrm>
          </p:grpSpPr>
          <p:cxnSp>
            <p:nvCxnSpPr>
              <p:cNvPr id="122" name="Straight Connector 121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Straight Arrow Connector 122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6" name="TextBox 115"/>
            <p:cNvSpPr txBox="1"/>
            <p:nvPr/>
          </p:nvSpPr>
          <p:spPr>
            <a:xfrm>
              <a:off x="1261964" y="2986874"/>
              <a:ext cx="2853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  <p:sp>
          <p:nvSpPr>
            <p:cNvPr id="117" name="Rounded Rectangle 16"/>
            <p:cNvSpPr/>
            <p:nvPr/>
          </p:nvSpPr>
          <p:spPr>
            <a:xfrm>
              <a:off x="1850874" y="3208714"/>
              <a:ext cx="331667" cy="193314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ounded Rectangle 16"/>
            <p:cNvSpPr/>
            <p:nvPr/>
          </p:nvSpPr>
          <p:spPr>
            <a:xfrm>
              <a:off x="1301838" y="3220128"/>
              <a:ext cx="541085" cy="188914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273510" y="3179301"/>
              <a:ext cx="700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ate2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818894" y="3171175"/>
              <a:ext cx="450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A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884195" y="2955325"/>
              <a:ext cx="47769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Y01</a:t>
              </a:r>
            </a:p>
          </p:txBody>
        </p:sp>
      </p:grpSp>
      <p:grpSp>
        <p:nvGrpSpPr>
          <p:cNvPr id="124" name="Group 123"/>
          <p:cNvGrpSpPr/>
          <p:nvPr/>
        </p:nvGrpSpPr>
        <p:grpSpPr>
          <a:xfrm>
            <a:off x="5199747" y="3669814"/>
            <a:ext cx="960061" cy="967242"/>
            <a:chOff x="5251846" y="1310761"/>
            <a:chExt cx="960061" cy="967242"/>
          </a:xfrm>
        </p:grpSpPr>
        <p:sp>
          <p:nvSpPr>
            <p:cNvPr id="125" name="Rounded Rectangle 12"/>
            <p:cNvSpPr/>
            <p:nvPr/>
          </p:nvSpPr>
          <p:spPr bwMode="auto">
            <a:xfrm>
              <a:off x="5251846" y="1768320"/>
              <a:ext cx="960061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5323178" y="1437882"/>
              <a:ext cx="530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G</a:t>
              </a:r>
            </a:p>
          </p:txBody>
        </p:sp>
        <p:sp>
          <p:nvSpPr>
            <p:cNvPr id="127" name="Rounded Rectangle 16"/>
            <p:cNvSpPr/>
            <p:nvPr/>
          </p:nvSpPr>
          <p:spPr>
            <a:xfrm>
              <a:off x="5447331" y="1707451"/>
              <a:ext cx="764576" cy="128311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571654" y="1645545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5551830" y="1310761"/>
              <a:ext cx="47769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Y02</a:t>
              </a:r>
            </a:p>
          </p:txBody>
        </p:sp>
        <p:grpSp>
          <p:nvGrpSpPr>
            <p:cNvPr id="130" name="Group 129"/>
            <p:cNvGrpSpPr/>
            <p:nvPr/>
          </p:nvGrpSpPr>
          <p:grpSpPr>
            <a:xfrm>
              <a:off x="5435307" y="1657147"/>
              <a:ext cx="185920" cy="114770"/>
              <a:chOff x="2376911" y="5029200"/>
              <a:chExt cx="185920" cy="114770"/>
            </a:xfrm>
          </p:grpSpPr>
          <p:cxnSp>
            <p:nvCxnSpPr>
              <p:cNvPr id="134" name="Straight Connector 133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Arrow Connector 134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" name="Group 130"/>
            <p:cNvGrpSpPr/>
            <p:nvPr/>
          </p:nvGrpSpPr>
          <p:grpSpPr>
            <a:xfrm>
              <a:off x="5336308" y="2031782"/>
              <a:ext cx="510076" cy="246221"/>
              <a:chOff x="1802909" y="2012907"/>
              <a:chExt cx="510076" cy="246221"/>
            </a:xfrm>
          </p:grpSpPr>
          <p:sp>
            <p:nvSpPr>
              <p:cNvPr id="132" name="Rounded Rectangle 16"/>
              <p:cNvSpPr/>
              <p:nvPr/>
            </p:nvSpPr>
            <p:spPr>
              <a:xfrm>
                <a:off x="1846483" y="2073553"/>
                <a:ext cx="393964" cy="150307"/>
              </a:xfrm>
              <a:prstGeom prst="round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1802909" y="201290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r>
                  <a:rPr lang="en-US" sz="1000" baseline="30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</p:grpSp>
      </p:grpSp>
      <p:grpSp>
        <p:nvGrpSpPr>
          <p:cNvPr id="136" name="Group 135"/>
          <p:cNvGrpSpPr/>
          <p:nvPr/>
        </p:nvGrpSpPr>
        <p:grpSpPr>
          <a:xfrm>
            <a:off x="6397368" y="3688251"/>
            <a:ext cx="1711004" cy="932112"/>
            <a:chOff x="6423346" y="3125061"/>
            <a:chExt cx="1711004" cy="932112"/>
          </a:xfrm>
        </p:grpSpPr>
        <p:sp>
          <p:nvSpPr>
            <p:cNvPr id="137" name="TextBox 136"/>
            <p:cNvSpPr txBox="1"/>
            <p:nvPr/>
          </p:nvSpPr>
          <p:spPr>
            <a:xfrm>
              <a:off x="7045568" y="3125061"/>
              <a:ext cx="477695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Y03</a:t>
              </a:r>
            </a:p>
          </p:txBody>
        </p:sp>
        <p:sp>
          <p:nvSpPr>
            <p:cNvPr id="138" name="Rounded Rectangle 12"/>
            <p:cNvSpPr/>
            <p:nvPr/>
          </p:nvSpPr>
          <p:spPr bwMode="auto">
            <a:xfrm>
              <a:off x="6423346" y="3546043"/>
              <a:ext cx="1711004" cy="383630"/>
            </a:xfrm>
            <a:prstGeom prst="roundRect">
              <a:avLst/>
            </a:prstGeom>
            <a:noFill/>
            <a:ln w="254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Rounded Rectangle 16"/>
            <p:cNvSpPr/>
            <p:nvPr/>
          </p:nvSpPr>
          <p:spPr>
            <a:xfrm>
              <a:off x="7570985" y="3441872"/>
              <a:ext cx="451361" cy="207090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7543739" y="3427507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</a:p>
          </p:txBody>
        </p:sp>
        <p:sp>
          <p:nvSpPr>
            <p:cNvPr id="141" name="Rounded Rectangle 16"/>
            <p:cNvSpPr/>
            <p:nvPr/>
          </p:nvSpPr>
          <p:spPr>
            <a:xfrm>
              <a:off x="6532960" y="3850345"/>
              <a:ext cx="393964" cy="150307"/>
            </a:xfrm>
            <a:prstGeom prst="round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6460811" y="3780174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r>
                <a:rPr lang="en-US" sz="12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43" name="Group 142"/>
            <p:cNvGrpSpPr/>
            <p:nvPr/>
          </p:nvGrpSpPr>
          <p:grpSpPr>
            <a:xfrm>
              <a:off x="6658652" y="3413855"/>
              <a:ext cx="185920" cy="114770"/>
              <a:chOff x="2376911" y="5029200"/>
              <a:chExt cx="185920" cy="114770"/>
            </a:xfrm>
          </p:grpSpPr>
          <p:cxnSp>
            <p:nvCxnSpPr>
              <p:cNvPr id="149" name="Straight Connector 148"/>
              <p:cNvCxnSpPr/>
              <p:nvPr/>
            </p:nvCxnSpPr>
            <p:spPr>
              <a:xfrm flipV="1">
                <a:off x="2384285" y="5034370"/>
                <a:ext cx="929" cy="109600"/>
              </a:xfrm>
              <a:prstGeom prst="line">
                <a:avLst/>
              </a:prstGeom>
              <a:ln w="12700"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Arrow Connector 149"/>
              <p:cNvCxnSpPr/>
              <p:nvPr/>
            </p:nvCxnSpPr>
            <p:spPr>
              <a:xfrm flipV="1">
                <a:off x="2376911" y="5029200"/>
                <a:ext cx="185920" cy="5168"/>
              </a:xfrm>
              <a:prstGeom prst="straightConnector1">
                <a:avLst/>
              </a:prstGeom>
              <a:ln w="12700">
                <a:solidFill>
                  <a:srgbClr val="0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" name="TextBox 143"/>
            <p:cNvSpPr txBox="1"/>
            <p:nvPr/>
          </p:nvSpPr>
          <p:spPr>
            <a:xfrm>
              <a:off x="6642457" y="3230506"/>
              <a:ext cx="2853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  <p:sp>
          <p:nvSpPr>
            <p:cNvPr id="145" name="Rounded Rectangle 16"/>
            <p:cNvSpPr/>
            <p:nvPr/>
          </p:nvSpPr>
          <p:spPr>
            <a:xfrm>
              <a:off x="7231367" y="3452346"/>
              <a:ext cx="331667" cy="193314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7190056" y="3424138"/>
              <a:ext cx="450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A</a:t>
              </a:r>
            </a:p>
          </p:txBody>
        </p:sp>
        <p:sp>
          <p:nvSpPr>
            <p:cNvPr id="147" name="Rounded Rectangle 16"/>
            <p:cNvSpPr/>
            <p:nvPr/>
          </p:nvSpPr>
          <p:spPr>
            <a:xfrm>
              <a:off x="6682331" y="3463760"/>
              <a:ext cx="541085" cy="188914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6752420" y="3431974"/>
              <a:ext cx="700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ro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18101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27</TotalTime>
  <Words>56</Words>
  <Application>Microsoft Office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erson, Emily (GE Healthcare)</dc:creator>
  <cp:lastModifiedBy>Emily Anderson</cp:lastModifiedBy>
  <cp:revision>37</cp:revision>
  <cp:lastPrinted>2017-08-23T20:39:11Z</cp:lastPrinted>
  <dcterms:created xsi:type="dcterms:W3CDTF">2017-06-20T17:09:07Z</dcterms:created>
  <dcterms:modified xsi:type="dcterms:W3CDTF">2018-01-16T17:57:45Z</dcterms:modified>
</cp:coreProperties>
</file>